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A7EC"/>
    <a:srgbClr val="C8009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92" autoAdjust="0"/>
    <p:restoredTop sz="96247" autoAdjust="0"/>
  </p:normalViewPr>
  <p:slideViewPr>
    <p:cSldViewPr snapToGrid="0">
      <p:cViewPr>
        <p:scale>
          <a:sx n="70" d="100"/>
          <a:sy n="70" d="100"/>
        </p:scale>
        <p:origin x="270" y="6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B06088-404D-4AF9-A306-5B88899B8FA1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4C958F-2F59-41C1-9C76-3D5930C8B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959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4C958F-2F59-41C1-9C76-3D5930C8B36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151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91AAD5-14E9-4BC5-8DB5-6A9FDD93F0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D93FE3-618A-49EF-A46E-E18AC9CD90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4959FD-62F5-4E92-97B6-ECBC11FF7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5CA7EE-F97C-4079-B5D0-2789D3265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0E8A81-962D-4F2B-91E6-5ACBD96A4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634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FE780-C443-4220-B8B3-61B68EAA1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013C21-0FD9-4F6A-A333-7E3E2622A3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881495-B18F-471C-BBA4-1A95EC962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6FD574-E187-4FAB-BAA5-E1EB70721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C09FA2-9494-4775-BF2F-25BC72E2EB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562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2554F1F-BF11-4F85-9E6F-08CCA71A9D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BFCBB0-A799-40AA-BAA3-14F2C9ECB0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66C883-DD52-4B54-A1E0-7E5FBFBDF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A6604A-9768-46D9-BCD1-B67DFC013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585BDE-E7EF-4606-B521-6295F64D7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223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77C53-4E55-490E-AF97-08146694B6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432E86-73EA-46FA-8366-54CB004199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13A7C6-E279-4E34-A652-F0C5C652F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233B52-6EE6-466E-AEBE-D90C82F8F0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F61EF6-812D-49F5-A499-A6F7C03FD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221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1AEBD-4191-4466-923E-2CFD6331E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0DEEFB-1630-4260-842E-0E4080EF05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E9CB52-E596-4277-82C5-0FFAC9B4A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0FA820-5068-46DC-90ED-D4E894BA6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F3D07C-B1FA-44AC-A875-5816B9793F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160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B96CD4-66C1-4ECB-BE19-4C65681D85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7C2E7D-0B63-4C2B-B6F1-4B732FD35E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749D92-BB52-462F-B2DD-ACD9CBFD36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8C1184-9CA8-4F25-8733-72E8322CE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2A4E58-9476-4B01-9592-04BBE4D52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F8E5F3-E5C8-4ED2-A201-32F1AACDE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513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CBC78C-B9E2-442B-858B-8CA451484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72C020-B844-4F04-8024-BB51E334CA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D71052-F037-4FAA-B5ED-FABDC924E2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D5BBB1-BB78-4116-9B26-E9F94060E9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C22461-2A21-4D95-B95F-22F792F555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DA567E-0DFA-4EAE-9A0C-41DDC2AD4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A84414-8E7A-4843-A802-0C3AD2ED3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0565B3-AB5C-43F4-AC6A-06C8B6403E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600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E762E-A4CE-4F1B-9EBA-18901EA526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B1526A-33B7-4A9F-9CFC-E9BAFCF5B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2907536-7CD2-40C6-9EA7-F078B9528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AE1DE4-5E2D-466D-8D8D-F84F1F6B5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379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FB1B69-264D-43F7-AE0E-206461469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440A9C-8CD4-43B3-8B21-DE77FD1B3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9F4877-9446-4F59-9517-2412C28F1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91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29888C-5B01-44FB-A9F1-8528A8DF91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C29E87-830C-4F17-8C36-FDA0E44ADC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E4D5E1-9CEA-45CF-BCB2-E58F628E53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C56901-0972-43A0-9746-E62A0F16D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A1C003-40BB-4CD2-B8B7-7EFD492B0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CBE117-1316-4E4E-ADE3-DF2EC6DD8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187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DA2D9F-E225-46FF-B5FC-483FD2F091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B04776-5B0B-49DA-9449-1DA0D20DEE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9F57E9-492D-4E95-9A95-94D4E18533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819B5C-73D5-4564-A52E-8069B00B7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45DA90-EA00-4C1C-8A86-627EDC3C0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BB6121-828D-4509-A074-5D8CFF595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87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6B0371-B20C-4341-80D6-575409BD15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1BBFD5-8DEA-4FE8-98BD-34CFD1A570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6F3721-EECD-400F-ACE6-56954D9957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1932B-1459-41AC-AD38-D9DCD082967F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AB6F2D-2357-4AE1-A555-5293E20643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FDF00B-BE4F-4639-9409-4E418DF8F8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B763C-CDCB-4700-9CE9-2CC3E4AC0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91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C54E331-98D4-DE2F-039D-A44C83D08472}"/>
              </a:ext>
            </a:extLst>
          </p:cNvPr>
          <p:cNvGrpSpPr/>
          <p:nvPr/>
        </p:nvGrpSpPr>
        <p:grpSpPr>
          <a:xfrm>
            <a:off x="383837" y="784184"/>
            <a:ext cx="3737617" cy="5954530"/>
            <a:chOff x="390661" y="220405"/>
            <a:chExt cx="3737617" cy="5954530"/>
          </a:xfrm>
        </p:grpSpPr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641633F0-017F-838F-F68A-881983D908E3}"/>
                </a:ext>
              </a:extLst>
            </p:cNvPr>
            <p:cNvSpPr/>
            <p:nvPr/>
          </p:nvSpPr>
          <p:spPr>
            <a:xfrm>
              <a:off x="390661" y="683064"/>
              <a:ext cx="1828800" cy="1828800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800" dirty="0"/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077A0ACF-A1AF-F70B-69B3-2D7D6AE7FC87}"/>
                </a:ext>
              </a:extLst>
            </p:cNvPr>
            <p:cNvSpPr/>
            <p:nvPr/>
          </p:nvSpPr>
          <p:spPr>
            <a:xfrm>
              <a:off x="2219461" y="683064"/>
              <a:ext cx="1828800" cy="1828800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800" dirty="0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D0E6D765-7228-E9EF-79FA-86D6196C203B}"/>
                </a:ext>
              </a:extLst>
            </p:cNvPr>
            <p:cNvSpPr/>
            <p:nvPr/>
          </p:nvSpPr>
          <p:spPr>
            <a:xfrm>
              <a:off x="390661" y="2511863"/>
              <a:ext cx="1828800" cy="1841279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1C8C6095-A7F9-87DB-0C7D-ED5F99607D0B}"/>
                </a:ext>
              </a:extLst>
            </p:cNvPr>
            <p:cNvSpPr/>
            <p:nvPr/>
          </p:nvSpPr>
          <p:spPr>
            <a:xfrm>
              <a:off x="2220691" y="2510720"/>
              <a:ext cx="1828800" cy="1837103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E300C626-9832-D45E-9966-8833BA669469}"/>
                </a:ext>
              </a:extLst>
            </p:cNvPr>
            <p:cNvSpPr/>
            <p:nvPr/>
          </p:nvSpPr>
          <p:spPr>
            <a:xfrm>
              <a:off x="2219075" y="4346135"/>
              <a:ext cx="1828800" cy="1828800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BEA3C090-166D-92A4-D5B4-8DFD0CE4C2AC}"/>
                </a:ext>
              </a:extLst>
            </p:cNvPr>
            <p:cNvSpPr/>
            <p:nvPr/>
          </p:nvSpPr>
          <p:spPr>
            <a:xfrm>
              <a:off x="390661" y="4353294"/>
              <a:ext cx="1828800" cy="182064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Flowchart: Connector 74">
              <a:extLst>
                <a:ext uri="{FF2B5EF4-FFF2-40B4-BE49-F238E27FC236}">
                  <a16:creationId xmlns:a16="http://schemas.microsoft.com/office/drawing/2014/main" id="{0227ADFF-0EE9-826F-3205-F10CBF1D5422}"/>
                </a:ext>
              </a:extLst>
            </p:cNvPr>
            <p:cNvSpPr/>
            <p:nvPr/>
          </p:nvSpPr>
          <p:spPr>
            <a:xfrm>
              <a:off x="1969288" y="1210106"/>
              <a:ext cx="640080" cy="640080"/>
            </a:xfrm>
            <a:prstGeom prst="flowChartConnector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6C0F717-CF6E-A13F-B012-81EE09BAD64B}"/>
                </a:ext>
              </a:extLst>
            </p:cNvPr>
            <p:cNvSpPr txBox="1"/>
            <p:nvPr/>
          </p:nvSpPr>
          <p:spPr>
            <a:xfrm>
              <a:off x="390661" y="220405"/>
              <a:ext cx="365721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/>
                <a:t>Allocation Error Tolerance = 0.2</a:t>
              </a:r>
            </a:p>
          </p:txBody>
        </p:sp>
        <p:sp>
          <p:nvSpPr>
            <p:cNvPr id="82" name="Flowchart: Connector 81">
              <a:extLst>
                <a:ext uri="{FF2B5EF4-FFF2-40B4-BE49-F238E27FC236}">
                  <a16:creationId xmlns:a16="http://schemas.microsoft.com/office/drawing/2014/main" id="{E1C96DA0-B7CB-6B72-01F4-46D94A018F06}"/>
                </a:ext>
              </a:extLst>
            </p:cNvPr>
            <p:cNvSpPr/>
            <p:nvPr/>
          </p:nvSpPr>
          <p:spPr>
            <a:xfrm>
              <a:off x="1649248" y="4973658"/>
              <a:ext cx="640080" cy="640080"/>
            </a:xfrm>
            <a:prstGeom prst="flowChartConnector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Flowchart: Connector 82">
              <a:extLst>
                <a:ext uri="{FF2B5EF4-FFF2-40B4-BE49-F238E27FC236}">
                  <a16:creationId xmlns:a16="http://schemas.microsoft.com/office/drawing/2014/main" id="{9477AE40-C4A4-D2FB-8A15-0F8480998C1B}"/>
                </a:ext>
              </a:extLst>
            </p:cNvPr>
            <p:cNvSpPr/>
            <p:nvPr/>
          </p:nvSpPr>
          <p:spPr>
            <a:xfrm>
              <a:off x="1919424" y="3137699"/>
              <a:ext cx="640080" cy="640080"/>
            </a:xfrm>
            <a:prstGeom prst="flowChartConnector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52DAF18-3152-F110-4782-BDBC59B047CA}"/>
                </a:ext>
              </a:extLst>
            </p:cNvPr>
            <p:cNvSpPr txBox="1"/>
            <p:nvPr/>
          </p:nvSpPr>
          <p:spPr>
            <a:xfrm>
              <a:off x="432970" y="2111603"/>
              <a:ext cx="180059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6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9FE0044C-4B7C-D4E6-F785-37095215DB76}"/>
                </a:ext>
              </a:extLst>
            </p:cNvPr>
            <p:cNvSpPr txBox="1"/>
            <p:nvPr/>
          </p:nvSpPr>
          <p:spPr>
            <a:xfrm>
              <a:off x="2275072" y="2115334"/>
              <a:ext cx="1713751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4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5E6FE7C2-12B8-31F6-E892-736F6FAD72B8}"/>
                </a:ext>
              </a:extLst>
            </p:cNvPr>
            <p:cNvSpPr txBox="1"/>
            <p:nvPr/>
          </p:nvSpPr>
          <p:spPr>
            <a:xfrm>
              <a:off x="415214" y="3918692"/>
              <a:ext cx="182841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 5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69380248-D107-2803-7A30-ECE85AA0B841}"/>
                </a:ext>
              </a:extLst>
            </p:cNvPr>
            <p:cNvSpPr txBox="1"/>
            <p:nvPr/>
          </p:nvSpPr>
          <p:spPr>
            <a:xfrm>
              <a:off x="2258965" y="3918692"/>
              <a:ext cx="182841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5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C979BD3F-F865-71E7-4A2E-B3412954F8D4}"/>
                </a:ext>
              </a:extLst>
            </p:cNvPr>
            <p:cNvSpPr txBox="1"/>
            <p:nvPr/>
          </p:nvSpPr>
          <p:spPr>
            <a:xfrm>
              <a:off x="2299864" y="5758248"/>
              <a:ext cx="182841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9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F622D515-B375-06E3-8177-3FD47430196F}"/>
                </a:ext>
              </a:extLst>
            </p:cNvPr>
            <p:cNvSpPr txBox="1"/>
            <p:nvPr/>
          </p:nvSpPr>
          <p:spPr>
            <a:xfrm>
              <a:off x="415214" y="5762357"/>
              <a:ext cx="1802245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1</a:t>
              </a:r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EC0155C8-9DE5-1FA1-8E4E-36D8C88DBD13}"/>
              </a:ext>
            </a:extLst>
          </p:cNvPr>
          <p:cNvGrpSpPr/>
          <p:nvPr/>
        </p:nvGrpSpPr>
        <p:grpSpPr>
          <a:xfrm>
            <a:off x="4259996" y="784184"/>
            <a:ext cx="3701741" cy="5953536"/>
            <a:chOff x="387516" y="221398"/>
            <a:chExt cx="3701741" cy="5953536"/>
          </a:xfrm>
        </p:grpSpPr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B5D59DA6-8B17-1AAF-2FB2-19C67B31CB78}"/>
                </a:ext>
              </a:extLst>
            </p:cNvPr>
            <p:cNvSpPr/>
            <p:nvPr/>
          </p:nvSpPr>
          <p:spPr>
            <a:xfrm>
              <a:off x="390661" y="683064"/>
              <a:ext cx="1828800" cy="1828800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800" dirty="0"/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77AF9300-6610-C55F-D35F-C64153222602}"/>
                </a:ext>
              </a:extLst>
            </p:cNvPr>
            <p:cNvSpPr/>
            <p:nvPr/>
          </p:nvSpPr>
          <p:spPr>
            <a:xfrm>
              <a:off x="2219461" y="683064"/>
              <a:ext cx="1828800" cy="1828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800" dirty="0"/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1D5C3C29-7A14-6B91-2B1A-D4AEC256C694}"/>
                </a:ext>
              </a:extLst>
            </p:cNvPr>
            <p:cNvSpPr/>
            <p:nvPr/>
          </p:nvSpPr>
          <p:spPr>
            <a:xfrm>
              <a:off x="390661" y="2511863"/>
              <a:ext cx="1828800" cy="1854147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2E43B1F1-322B-27B5-70D0-B80D0DB41A7B}"/>
                </a:ext>
              </a:extLst>
            </p:cNvPr>
            <p:cNvSpPr/>
            <p:nvPr/>
          </p:nvSpPr>
          <p:spPr>
            <a:xfrm>
              <a:off x="2220691" y="2519023"/>
              <a:ext cx="1824040" cy="1834120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56DE4E4E-3548-4693-C214-1E69D2EF235B}"/>
                </a:ext>
              </a:extLst>
            </p:cNvPr>
            <p:cNvSpPr/>
            <p:nvPr/>
          </p:nvSpPr>
          <p:spPr>
            <a:xfrm>
              <a:off x="2219075" y="4354135"/>
              <a:ext cx="1828800" cy="1820799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90389270-8F3A-8061-C1BB-12DF149AC68E}"/>
                </a:ext>
              </a:extLst>
            </p:cNvPr>
            <p:cNvSpPr/>
            <p:nvPr/>
          </p:nvSpPr>
          <p:spPr>
            <a:xfrm>
              <a:off x="390661" y="4354135"/>
              <a:ext cx="1828800" cy="1819807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Flowchart: Connector 107">
              <a:extLst>
                <a:ext uri="{FF2B5EF4-FFF2-40B4-BE49-F238E27FC236}">
                  <a16:creationId xmlns:a16="http://schemas.microsoft.com/office/drawing/2014/main" id="{6D5E7627-7FEE-6784-16BC-91ECCD618D45}"/>
                </a:ext>
              </a:extLst>
            </p:cNvPr>
            <p:cNvSpPr/>
            <p:nvPr/>
          </p:nvSpPr>
          <p:spPr>
            <a:xfrm>
              <a:off x="1969288" y="1210106"/>
              <a:ext cx="640080" cy="640080"/>
            </a:xfrm>
            <a:prstGeom prst="flowChartConnector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AD748000-4563-B3EB-64E6-5AA6862CE1D3}"/>
                </a:ext>
              </a:extLst>
            </p:cNvPr>
            <p:cNvSpPr txBox="1"/>
            <p:nvPr/>
          </p:nvSpPr>
          <p:spPr>
            <a:xfrm>
              <a:off x="387517" y="221398"/>
              <a:ext cx="365721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/>
                <a:t>Allocation Error Tolerance = 0.4</a:t>
              </a:r>
            </a:p>
          </p:txBody>
        </p:sp>
        <p:sp>
          <p:nvSpPr>
            <p:cNvPr id="110" name="Flowchart: Connector 109">
              <a:extLst>
                <a:ext uri="{FF2B5EF4-FFF2-40B4-BE49-F238E27FC236}">
                  <a16:creationId xmlns:a16="http://schemas.microsoft.com/office/drawing/2014/main" id="{8F4CA1F7-8A2D-4154-BDCD-828198D17A78}"/>
                </a:ext>
              </a:extLst>
            </p:cNvPr>
            <p:cNvSpPr/>
            <p:nvPr/>
          </p:nvSpPr>
          <p:spPr>
            <a:xfrm>
              <a:off x="1649248" y="4973658"/>
              <a:ext cx="640080" cy="640080"/>
            </a:xfrm>
            <a:prstGeom prst="flowChartConnector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1" name="Flowchart: Connector 110">
              <a:extLst>
                <a:ext uri="{FF2B5EF4-FFF2-40B4-BE49-F238E27FC236}">
                  <a16:creationId xmlns:a16="http://schemas.microsoft.com/office/drawing/2014/main" id="{59716036-A9D5-FEFA-1BCA-DE657C13F618}"/>
                </a:ext>
              </a:extLst>
            </p:cNvPr>
            <p:cNvSpPr/>
            <p:nvPr/>
          </p:nvSpPr>
          <p:spPr>
            <a:xfrm>
              <a:off x="1919424" y="3137699"/>
              <a:ext cx="640080" cy="640080"/>
            </a:xfrm>
            <a:prstGeom prst="flowChartConnector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11B0F032-52B4-3000-83B5-7F3C7049B4D4}"/>
                </a:ext>
              </a:extLst>
            </p:cNvPr>
            <p:cNvSpPr txBox="1"/>
            <p:nvPr/>
          </p:nvSpPr>
          <p:spPr>
            <a:xfrm>
              <a:off x="439711" y="2115102"/>
              <a:ext cx="182880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6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2F1A480-5508-5380-395B-56EB1815F36A}"/>
                </a:ext>
              </a:extLst>
            </p:cNvPr>
            <p:cNvSpPr txBox="1"/>
            <p:nvPr/>
          </p:nvSpPr>
          <p:spPr>
            <a:xfrm>
              <a:off x="2268511" y="2112596"/>
              <a:ext cx="1706199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4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AFA5A296-A1AB-1218-9CCB-773B7499D7AF}"/>
                </a:ext>
              </a:extLst>
            </p:cNvPr>
            <p:cNvSpPr txBox="1"/>
            <p:nvPr/>
          </p:nvSpPr>
          <p:spPr>
            <a:xfrm>
              <a:off x="387516" y="3919685"/>
              <a:ext cx="1775141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 5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933D44D9-2E94-A3E6-70BE-F7D457A070E9}"/>
                </a:ext>
              </a:extLst>
            </p:cNvPr>
            <p:cNvSpPr txBox="1"/>
            <p:nvPr/>
          </p:nvSpPr>
          <p:spPr>
            <a:xfrm>
              <a:off x="2247083" y="3919685"/>
              <a:ext cx="182880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5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7E082CE1-9923-7CFF-E18B-0329B2A8EC47}"/>
                </a:ext>
              </a:extLst>
            </p:cNvPr>
            <p:cNvSpPr txBox="1"/>
            <p:nvPr/>
          </p:nvSpPr>
          <p:spPr>
            <a:xfrm>
              <a:off x="2260845" y="5759241"/>
              <a:ext cx="1828412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9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8531C43F-6622-2521-7D52-A0F171E9CF0E}"/>
                </a:ext>
              </a:extLst>
            </p:cNvPr>
            <p:cNvSpPr txBox="1"/>
            <p:nvPr/>
          </p:nvSpPr>
          <p:spPr>
            <a:xfrm>
              <a:off x="460915" y="5762595"/>
              <a:ext cx="1828413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1</a:t>
              </a:r>
            </a:p>
          </p:txBody>
        </p:sp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1413BC5D-A447-11F3-AB0B-CCFDE899F30B}"/>
              </a:ext>
            </a:extLst>
          </p:cNvPr>
          <p:cNvGrpSpPr/>
          <p:nvPr/>
        </p:nvGrpSpPr>
        <p:grpSpPr>
          <a:xfrm>
            <a:off x="8179999" y="782274"/>
            <a:ext cx="3746266" cy="5955447"/>
            <a:chOff x="390661" y="219488"/>
            <a:chExt cx="3746266" cy="5955447"/>
          </a:xfrm>
        </p:grpSpPr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51B16BFE-40C0-47F1-20FA-ECE0CDD18E7D}"/>
                </a:ext>
              </a:extLst>
            </p:cNvPr>
            <p:cNvSpPr/>
            <p:nvPr/>
          </p:nvSpPr>
          <p:spPr>
            <a:xfrm>
              <a:off x="390661" y="683064"/>
              <a:ext cx="1828800" cy="1828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800" dirty="0"/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E6A1674D-B703-F238-B09D-BED3DE4C5E12}"/>
                </a:ext>
              </a:extLst>
            </p:cNvPr>
            <p:cNvSpPr/>
            <p:nvPr/>
          </p:nvSpPr>
          <p:spPr>
            <a:xfrm>
              <a:off x="2219461" y="683064"/>
              <a:ext cx="1828800" cy="1828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800" dirty="0"/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08CBB8F1-7A2D-81D6-33DF-4A606C88256D}"/>
                </a:ext>
              </a:extLst>
            </p:cNvPr>
            <p:cNvSpPr/>
            <p:nvPr/>
          </p:nvSpPr>
          <p:spPr>
            <a:xfrm>
              <a:off x="390661" y="2511864"/>
              <a:ext cx="1828800" cy="1828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068B7B5F-93F7-A5C7-DC7A-B1BB6C66E6A7}"/>
                </a:ext>
              </a:extLst>
            </p:cNvPr>
            <p:cNvSpPr/>
            <p:nvPr/>
          </p:nvSpPr>
          <p:spPr>
            <a:xfrm>
              <a:off x="2220691" y="2519023"/>
              <a:ext cx="1828800" cy="1828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7BA30B87-532D-1374-EC92-3BDF3F1E9901}"/>
                </a:ext>
              </a:extLst>
            </p:cNvPr>
            <p:cNvSpPr/>
            <p:nvPr/>
          </p:nvSpPr>
          <p:spPr>
            <a:xfrm>
              <a:off x="2219075" y="4346135"/>
              <a:ext cx="1828800" cy="1828800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8AC8052B-1BF2-F709-990D-4360F1AC9DCA}"/>
                </a:ext>
              </a:extLst>
            </p:cNvPr>
            <p:cNvSpPr/>
            <p:nvPr/>
          </p:nvSpPr>
          <p:spPr>
            <a:xfrm>
              <a:off x="390661" y="4345142"/>
              <a:ext cx="1828800" cy="1828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Flowchart: Connector 124">
              <a:extLst>
                <a:ext uri="{FF2B5EF4-FFF2-40B4-BE49-F238E27FC236}">
                  <a16:creationId xmlns:a16="http://schemas.microsoft.com/office/drawing/2014/main" id="{92AB41E6-AC4B-DDB0-91FD-5CE6BC557165}"/>
                </a:ext>
              </a:extLst>
            </p:cNvPr>
            <p:cNvSpPr/>
            <p:nvPr/>
          </p:nvSpPr>
          <p:spPr>
            <a:xfrm>
              <a:off x="1969288" y="1210106"/>
              <a:ext cx="640080" cy="640080"/>
            </a:xfrm>
            <a:prstGeom prst="flowChartConnector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F94A1655-54DF-2575-2518-BFF326E1433C}"/>
                </a:ext>
              </a:extLst>
            </p:cNvPr>
            <p:cNvSpPr txBox="1"/>
            <p:nvPr/>
          </p:nvSpPr>
          <p:spPr>
            <a:xfrm>
              <a:off x="424047" y="219488"/>
              <a:ext cx="363114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/>
                <a:t>Allocation Error Tolerance = 0.6</a:t>
              </a:r>
            </a:p>
          </p:txBody>
        </p:sp>
        <p:sp>
          <p:nvSpPr>
            <p:cNvPr id="127" name="Flowchart: Connector 126">
              <a:extLst>
                <a:ext uri="{FF2B5EF4-FFF2-40B4-BE49-F238E27FC236}">
                  <a16:creationId xmlns:a16="http://schemas.microsoft.com/office/drawing/2014/main" id="{18089A16-ECC7-2EA9-1A5B-434E713FCC55}"/>
                </a:ext>
              </a:extLst>
            </p:cNvPr>
            <p:cNvSpPr/>
            <p:nvPr/>
          </p:nvSpPr>
          <p:spPr>
            <a:xfrm>
              <a:off x="1649248" y="4973658"/>
              <a:ext cx="640080" cy="640080"/>
            </a:xfrm>
            <a:prstGeom prst="flowChartConnector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8" name="Flowchart: Connector 127">
              <a:extLst>
                <a:ext uri="{FF2B5EF4-FFF2-40B4-BE49-F238E27FC236}">
                  <a16:creationId xmlns:a16="http://schemas.microsoft.com/office/drawing/2014/main" id="{47A01217-7AC3-9871-F2A4-7EFB7BE161D1}"/>
                </a:ext>
              </a:extLst>
            </p:cNvPr>
            <p:cNvSpPr/>
            <p:nvPr/>
          </p:nvSpPr>
          <p:spPr>
            <a:xfrm>
              <a:off x="1919424" y="3137699"/>
              <a:ext cx="640080" cy="640080"/>
            </a:xfrm>
            <a:prstGeom prst="flowChartConnector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621D322E-81A8-75BF-7D0E-1BB6611CE0E0}"/>
                </a:ext>
              </a:extLst>
            </p:cNvPr>
            <p:cNvSpPr txBox="1"/>
            <p:nvPr/>
          </p:nvSpPr>
          <p:spPr>
            <a:xfrm>
              <a:off x="460528" y="2111603"/>
              <a:ext cx="182880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6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BFBD54D6-2F6B-0548-4DA5-B1B7793D280B}"/>
                </a:ext>
              </a:extLst>
            </p:cNvPr>
            <p:cNvSpPr txBox="1"/>
            <p:nvPr/>
          </p:nvSpPr>
          <p:spPr>
            <a:xfrm>
              <a:off x="2289328" y="2103695"/>
              <a:ext cx="182880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4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37051B95-BD97-2247-5386-D9F5DF21C8ED}"/>
                </a:ext>
              </a:extLst>
            </p:cNvPr>
            <p:cNvSpPr txBox="1"/>
            <p:nvPr/>
          </p:nvSpPr>
          <p:spPr>
            <a:xfrm>
              <a:off x="425595" y="3919685"/>
              <a:ext cx="182880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 5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0A27522C-145D-CBD5-E540-49338050EB7E}"/>
                </a:ext>
              </a:extLst>
            </p:cNvPr>
            <p:cNvSpPr txBox="1"/>
            <p:nvPr/>
          </p:nvSpPr>
          <p:spPr>
            <a:xfrm>
              <a:off x="2254395" y="3930265"/>
              <a:ext cx="1800792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5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B6DFEC65-43FB-8ED5-BED5-D1A28C05802D}"/>
                </a:ext>
              </a:extLst>
            </p:cNvPr>
            <p:cNvSpPr txBox="1"/>
            <p:nvPr/>
          </p:nvSpPr>
          <p:spPr>
            <a:xfrm>
              <a:off x="2272151" y="5759241"/>
              <a:ext cx="1864776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9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90A54B52-3309-9EDD-D9F9-82F110439DFA}"/>
                </a:ext>
              </a:extLst>
            </p:cNvPr>
            <p:cNvSpPr txBox="1"/>
            <p:nvPr/>
          </p:nvSpPr>
          <p:spPr>
            <a:xfrm>
              <a:off x="479714" y="5765016"/>
              <a:ext cx="1828799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000" dirty="0"/>
                <a:t>Error risk = 0.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60423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345</TotalTime>
  <Words>94</Words>
  <Application>Microsoft Office PowerPoint</Application>
  <PresentationFormat>Widescreen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Task</dc:title>
  <dc:creator>Nathan Tarr</dc:creator>
  <cp:lastModifiedBy>Nathan Moloney Tarr</cp:lastModifiedBy>
  <cp:revision>176</cp:revision>
  <dcterms:created xsi:type="dcterms:W3CDTF">2021-09-01T13:47:38Z</dcterms:created>
  <dcterms:modified xsi:type="dcterms:W3CDTF">2025-02-04T17:11:21Z</dcterms:modified>
</cp:coreProperties>
</file>